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E63F6CE-7EFF-9F1D-417A-7CBE8499AB6F}" name="Philip Li" initials="PL" userId="S::PLi@novocure.com::2d5ea2a8-2d0d-407c-9956-046846ad4e84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252" y="-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6910D6-D1BD-4150-82EC-C655A64EFC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1CCE2D-E5F2-4744-9E72-6115D90EB6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9F4714-D032-4C53-B2BC-B6163E140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9768D-24D5-4DD3-9CC2-4053C47EC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20F215-7928-45A9-B42E-33BC72ACCB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478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5E2E90-4150-4E1D-9AD0-3393CFEA15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3AD666-8F6D-4181-B660-17664E2A20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E7D6FB-81D8-4DCC-8F95-28BC3C179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34A7C0-B404-4DFE-9E5B-88D7FC615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83EA84-2291-4659-B347-1F85B3231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336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539112-F661-456A-9250-C40433CC22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CB587E-17E7-4130-B388-6D565DFC7D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89CEE3-0394-4DF6-B041-AFF2FE5BD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CB5CFC-6DF5-4C1C-8884-85B8EDD88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689B71-8C21-4B20-A9D1-3EE7E1ECE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703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AA369B-E510-41BA-A2DC-FF0B7067FB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A6441B-366B-4CDF-B7A6-93874CF56F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E451BA-7DF3-4B58-90A9-A00184683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D564E0-B083-4D21-8FBA-84DB8361D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B6B11C-FB47-4D24-A6DF-C02CC7A58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382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67C288-840F-498E-9533-E90697B50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96FE2C-733E-451B-A333-F0F5AA2A8A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1B28B8-16F4-4704-94EB-923ED3182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43719D-4B65-4773-B0BC-A9A9D7890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A0EA9B-BB6C-44C4-A1FD-C5C61240FA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133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837596-ED58-46B4-87DB-76AA9B5F78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48A6C0-2573-4745-AAB2-2A1E22BBAE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C53D25-48E3-4D4B-9A0E-570780A6E1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68595C-2839-4DD5-8AA0-3BDD9E107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682DCF-D4D9-4150-A26B-27C6E93AA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39B9CA-0797-4D50-BDC6-092DE374E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078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7AFEBE-7270-43B7-91CE-BE2AE349C5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BA23A3-C091-4BA8-9317-83BFCEAC10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A1E1F3-1C74-4416-84DF-6E9A217108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F013A24-D3DE-47BB-9662-2B17032FCE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1D361DB-7929-464C-8366-1569914A80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1B911-73EC-4128-A0E8-51CEE5C0B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3DBF57-88E9-464C-9B24-B3660A540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4175B30-2530-419A-9038-91E08D044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742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5798A7-F991-4193-ACB0-9E30D4AB91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C044F2-FFFC-4B29-A6BD-615D7E935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9BD7DE-B22D-41DB-AB77-286FAADA7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9A339E-2CF0-4D0D-AAC5-93F496175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647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501B03-F6EF-4979-9F08-0140719AB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156786-521C-48AB-AE87-21BA5AC4D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A5BDB7-9533-4EDB-8732-96B26A9F6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285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502B5D-4971-4D60-8A37-73E1802DA5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0ED5FF-BE8A-4791-A35D-0CD9AF3A76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698097-E106-48FB-96C7-5101345914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4CD60A-D127-4749-ABF6-2AC65CEDF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C2156A-3348-40CD-BE23-7601FAC96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3F536A-3295-434C-80A6-FF999DA0C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366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5E4A4F-CE56-4BE3-B103-6C4775180C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35036A-86F0-4066-BEDA-5EDFC71164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FA8E45-2BC9-4416-9B2C-FA0E6DCFA2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D1B89D-146D-4FE8-800B-978BCB200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7C3455-C576-44C4-92D7-812F9103CF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BD3DCF-4E4A-4CE6-9C22-C449E866D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932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830D4FC-ADE1-4DE5-B9D9-C161A91FFB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2B4A6D-FCAB-4D81-9EF1-286D9ED4B3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858EB7-5D9F-43A7-BE6B-9EB936F3CE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B523B-F9B2-42AD-BB4B-5ABEF615A0EC}" type="datetimeFigureOut">
              <a:rPr lang="en-US" smtClean="0"/>
              <a:t>10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1D7009-4790-47BB-B305-6587AA67A8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CFDCFA-A030-4EDD-B5E9-01C190DA6F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42481-A531-403B-8A94-A2EE06470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636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75" descr="A white rat on a metal piece of machinery&#10;&#10;Description automatically generated">
            <a:extLst>
              <a:ext uri="{FF2B5EF4-FFF2-40B4-BE49-F238E27FC236}">
                <a16:creationId xmlns:a16="http://schemas.microsoft.com/office/drawing/2014/main" id="{81C36FB9-0AE2-2BEE-1555-50AC47E70D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0185" y="224984"/>
            <a:ext cx="2376000" cy="158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8" name="Picture 57" descr="A machine with a control panel&#10;&#10;Description automatically generated">
            <a:extLst>
              <a:ext uri="{FF2B5EF4-FFF2-40B4-BE49-F238E27FC236}">
                <a16:creationId xmlns:a16="http://schemas.microsoft.com/office/drawing/2014/main" id="{33F39401-C271-75D7-118B-952633E2A08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4210" y="224984"/>
            <a:ext cx="2149477" cy="32242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6" name="Picture 65" descr="A white animal on a machine&#10;&#10;Description automatically generated">
            <a:extLst>
              <a:ext uri="{FF2B5EF4-FFF2-40B4-BE49-F238E27FC236}">
                <a16:creationId xmlns:a16="http://schemas.microsoft.com/office/drawing/2014/main" id="{67C0FCDE-C8B1-BCC1-C062-8D0C15C29BE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0801" y="224984"/>
            <a:ext cx="2149477" cy="32242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15970FED-0222-1A32-4438-7550885E3AB9}"/>
              </a:ext>
            </a:extLst>
          </p:cNvPr>
          <p:cNvSpPr txBox="1"/>
          <p:nvPr/>
        </p:nvSpPr>
        <p:spPr>
          <a:xfrm>
            <a:off x="4274325" y="15326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  <a:endParaRPr lang="en-IL" b="1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73E80FA-32A6-C01E-0255-AF355B72A52D}"/>
              </a:ext>
            </a:extLst>
          </p:cNvPr>
          <p:cNvSpPr txBox="1"/>
          <p:nvPr/>
        </p:nvSpPr>
        <p:spPr>
          <a:xfrm>
            <a:off x="2036977" y="15326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en-IL" b="1" dirty="0"/>
          </a:p>
        </p:txBody>
      </p:sp>
      <p:pic>
        <p:nvPicPr>
          <p:cNvPr id="74" name="Picture 73" descr="A white rat on a machine&#10;&#10;Description automatically generated">
            <a:extLst>
              <a:ext uri="{FF2B5EF4-FFF2-40B4-BE49-F238E27FC236}">
                <a16:creationId xmlns:a16="http://schemas.microsoft.com/office/drawing/2014/main" id="{6CFBE4F8-8FC6-9CC2-8A7D-A7794608D7C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0185" y="1865200"/>
            <a:ext cx="2376000" cy="158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99F88174-92E4-835E-E9E4-8475D4488208}"/>
              </a:ext>
            </a:extLst>
          </p:cNvPr>
          <p:cNvSpPr txBox="1"/>
          <p:nvPr/>
        </p:nvSpPr>
        <p:spPr>
          <a:xfrm>
            <a:off x="4274325" y="1804425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  <a:endParaRPr lang="en-IL" b="1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98DAEBF-D0BF-5F07-8D9D-836C63F33B13}"/>
              </a:ext>
            </a:extLst>
          </p:cNvPr>
          <p:cNvSpPr txBox="1"/>
          <p:nvPr/>
        </p:nvSpPr>
        <p:spPr>
          <a:xfrm>
            <a:off x="6754603" y="15326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</a:t>
            </a:r>
            <a:endParaRPr lang="en-IL" b="1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8F52B355-58C9-364C-DFC2-370056D9846F}"/>
              </a:ext>
            </a:extLst>
          </p:cNvPr>
          <p:cNvSpPr txBox="1"/>
          <p:nvPr/>
        </p:nvSpPr>
        <p:spPr>
          <a:xfrm>
            <a:off x="102730" y="15326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en-IL" b="1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E7DC408-29F4-D8EB-7856-E012F8BBF102}"/>
              </a:ext>
            </a:extLst>
          </p:cNvPr>
          <p:cNvGrpSpPr/>
          <p:nvPr/>
        </p:nvGrpSpPr>
        <p:grpSpPr>
          <a:xfrm>
            <a:off x="460930" y="263828"/>
            <a:ext cx="1485087" cy="3944803"/>
            <a:chOff x="460930" y="263828"/>
            <a:chExt cx="1485087" cy="3944803"/>
          </a:xfrm>
        </p:grpSpPr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C1D9A50F-EFAF-6055-105D-42582ACCE461}"/>
                </a:ext>
              </a:extLst>
            </p:cNvPr>
            <p:cNvSpPr/>
            <p:nvPr/>
          </p:nvSpPr>
          <p:spPr>
            <a:xfrm>
              <a:off x="460930" y="2245660"/>
              <a:ext cx="1485087" cy="1962971"/>
            </a:xfrm>
            <a:prstGeom prst="rect">
              <a:avLst/>
            </a:prstGeom>
            <a:solidFill>
              <a:srgbClr val="CC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77ECDC1A-64E5-EA89-FDFA-9A9199B3E35A}"/>
                </a:ext>
              </a:extLst>
            </p:cNvPr>
            <p:cNvSpPr/>
            <p:nvPr/>
          </p:nvSpPr>
          <p:spPr>
            <a:xfrm>
              <a:off x="460930" y="1090495"/>
              <a:ext cx="1485087" cy="111021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cxnSp>
          <p:nvCxnSpPr>
            <p:cNvPr id="86" name="Straight Arrow Connector 85">
              <a:extLst>
                <a:ext uri="{FF2B5EF4-FFF2-40B4-BE49-F238E27FC236}">
                  <a16:creationId xmlns:a16="http://schemas.microsoft.com/office/drawing/2014/main" id="{36A52B28-5261-CE0F-E0D5-7951988610FE}"/>
                </a:ext>
              </a:extLst>
            </p:cNvPr>
            <p:cNvCxnSpPr>
              <a:cxnSpLocks/>
            </p:cNvCxnSpPr>
            <p:nvPr/>
          </p:nvCxnSpPr>
          <p:spPr>
            <a:xfrm>
              <a:off x="1203473" y="3020631"/>
              <a:ext cx="0" cy="118800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Arrow Connector 87">
              <a:extLst>
                <a:ext uri="{FF2B5EF4-FFF2-40B4-BE49-F238E27FC236}">
                  <a16:creationId xmlns:a16="http://schemas.microsoft.com/office/drawing/2014/main" id="{780FF218-984C-058A-8F44-BD1E955EE140}"/>
                </a:ext>
              </a:extLst>
            </p:cNvPr>
            <p:cNvCxnSpPr>
              <a:cxnSpLocks/>
            </p:cNvCxnSpPr>
            <p:nvPr/>
          </p:nvCxnSpPr>
          <p:spPr>
            <a:xfrm>
              <a:off x="1203473" y="1019353"/>
              <a:ext cx="0" cy="140400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Rectangle: Rounded Corners 88">
              <a:extLst>
                <a:ext uri="{FF2B5EF4-FFF2-40B4-BE49-F238E27FC236}">
                  <a16:creationId xmlns:a16="http://schemas.microsoft.com/office/drawing/2014/main" id="{F12B80EA-5FE7-B1D8-80EF-490294E7D608}"/>
                </a:ext>
              </a:extLst>
            </p:cNvPr>
            <p:cNvSpPr/>
            <p:nvPr/>
          </p:nvSpPr>
          <p:spPr>
            <a:xfrm>
              <a:off x="605197" y="1173711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90" name="Rectangle: Rounded Corners 89">
              <a:extLst>
                <a:ext uri="{FF2B5EF4-FFF2-40B4-BE49-F238E27FC236}">
                  <a16:creationId xmlns:a16="http://schemas.microsoft.com/office/drawing/2014/main" id="{530EBD64-DBC0-5255-AB35-24500109FD9E}"/>
                </a:ext>
              </a:extLst>
            </p:cNvPr>
            <p:cNvSpPr/>
            <p:nvPr/>
          </p:nvSpPr>
          <p:spPr>
            <a:xfrm>
              <a:off x="605197" y="787780"/>
              <a:ext cx="1196553" cy="239601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93" name="Rectangle: Rounded Corners 92">
              <a:extLst>
                <a:ext uri="{FF2B5EF4-FFF2-40B4-BE49-F238E27FC236}">
                  <a16:creationId xmlns:a16="http://schemas.microsoft.com/office/drawing/2014/main" id="{AA4DFE69-BFD2-E0C7-D858-AF00D68A4B2E}"/>
                </a:ext>
              </a:extLst>
            </p:cNvPr>
            <p:cNvSpPr/>
            <p:nvPr/>
          </p:nvSpPr>
          <p:spPr>
            <a:xfrm>
              <a:off x="605197" y="1525900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95" name="Rectangle: Rounded Corners 94">
              <a:extLst>
                <a:ext uri="{FF2B5EF4-FFF2-40B4-BE49-F238E27FC236}">
                  <a16:creationId xmlns:a16="http://schemas.microsoft.com/office/drawing/2014/main" id="{B897702C-3EBA-81B5-DCEA-08AA3A37463A}"/>
                </a:ext>
              </a:extLst>
            </p:cNvPr>
            <p:cNvSpPr/>
            <p:nvPr/>
          </p:nvSpPr>
          <p:spPr>
            <a:xfrm>
              <a:off x="627473" y="2432848"/>
              <a:ext cx="1152000" cy="601385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69996F33-039F-407E-A994-E50011EB0F32}"/>
                </a:ext>
              </a:extLst>
            </p:cNvPr>
            <p:cNvSpPr txBox="1"/>
            <p:nvPr/>
          </p:nvSpPr>
          <p:spPr>
            <a:xfrm>
              <a:off x="605197" y="1177900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rray assembly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C0E03EB9-5D1F-5785-B8E8-A20699D3C0DD}"/>
                </a:ext>
              </a:extLst>
            </p:cNvPr>
            <p:cNvSpPr txBox="1"/>
            <p:nvPr/>
          </p:nvSpPr>
          <p:spPr>
            <a:xfrm>
              <a:off x="605197" y="765601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orso depilation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50934995-BC9B-800F-4E79-4F46FE9ABF89}"/>
                </a:ext>
              </a:extLst>
            </p:cNvPr>
            <p:cNvSpPr txBox="1"/>
            <p:nvPr/>
          </p:nvSpPr>
          <p:spPr>
            <a:xfrm>
              <a:off x="591473" y="1530089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eeling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6AA1B548-144D-647C-D5DF-4C17D2C19B86}"/>
                </a:ext>
              </a:extLst>
            </p:cNvPr>
            <p:cNvSpPr txBox="1"/>
            <p:nvPr/>
          </p:nvSpPr>
          <p:spPr>
            <a:xfrm>
              <a:off x="627472" y="2408276"/>
              <a:ext cx="11520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opical Skin Care product application</a:t>
              </a:r>
            </a:p>
          </p:txBody>
        </p:sp>
        <p:sp>
          <p:nvSpPr>
            <p:cNvPr id="106" name="Rectangle: Rounded Corners 105">
              <a:extLst>
                <a:ext uri="{FF2B5EF4-FFF2-40B4-BE49-F238E27FC236}">
                  <a16:creationId xmlns:a16="http://schemas.microsoft.com/office/drawing/2014/main" id="{F9499953-21FF-E988-0EDD-C5B20B0E2BE6}"/>
                </a:ext>
              </a:extLst>
            </p:cNvPr>
            <p:cNvSpPr/>
            <p:nvPr/>
          </p:nvSpPr>
          <p:spPr>
            <a:xfrm>
              <a:off x="605197" y="1874185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C1D6B088-63CC-0659-D9C8-86B17E6D9B50}"/>
                </a:ext>
              </a:extLst>
            </p:cNvPr>
            <p:cNvSpPr txBox="1"/>
            <p:nvPr/>
          </p:nvSpPr>
          <p:spPr>
            <a:xfrm>
              <a:off x="605197" y="1878374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rray removal</a:t>
              </a:r>
            </a:p>
          </p:txBody>
        </p:sp>
        <p:sp>
          <p:nvSpPr>
            <p:cNvPr id="108" name="Rectangle: Rounded Corners 107">
              <a:extLst>
                <a:ext uri="{FF2B5EF4-FFF2-40B4-BE49-F238E27FC236}">
                  <a16:creationId xmlns:a16="http://schemas.microsoft.com/office/drawing/2014/main" id="{B9A2D2B1-2930-5321-D3B4-45FA1780E040}"/>
                </a:ext>
              </a:extLst>
            </p:cNvPr>
            <p:cNvSpPr/>
            <p:nvPr/>
          </p:nvSpPr>
          <p:spPr>
            <a:xfrm>
              <a:off x="605197" y="3150931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09" name="Rectangle: Rounded Corners 108">
              <a:extLst>
                <a:ext uri="{FF2B5EF4-FFF2-40B4-BE49-F238E27FC236}">
                  <a16:creationId xmlns:a16="http://schemas.microsoft.com/office/drawing/2014/main" id="{B1B61E6C-BCC8-87AA-94F0-0A62F1DD98B1}"/>
                </a:ext>
              </a:extLst>
            </p:cNvPr>
            <p:cNvSpPr/>
            <p:nvPr/>
          </p:nvSpPr>
          <p:spPr>
            <a:xfrm>
              <a:off x="605197" y="3503120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5B1C4222-20EF-9C3E-A31A-F1EA61F71DDD}"/>
                </a:ext>
              </a:extLst>
            </p:cNvPr>
            <p:cNvSpPr txBox="1"/>
            <p:nvPr/>
          </p:nvSpPr>
          <p:spPr>
            <a:xfrm>
              <a:off x="605197" y="3155120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rray assembly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9D5F6638-D330-C588-1A82-7864CC050693}"/>
                </a:ext>
              </a:extLst>
            </p:cNvPr>
            <p:cNvSpPr txBox="1"/>
            <p:nvPr/>
          </p:nvSpPr>
          <p:spPr>
            <a:xfrm>
              <a:off x="591473" y="3507309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eeling</a:t>
              </a:r>
            </a:p>
          </p:txBody>
        </p:sp>
        <p:sp>
          <p:nvSpPr>
            <p:cNvPr id="112" name="Rectangle: Rounded Corners 111">
              <a:extLst>
                <a:ext uri="{FF2B5EF4-FFF2-40B4-BE49-F238E27FC236}">
                  <a16:creationId xmlns:a16="http://schemas.microsoft.com/office/drawing/2014/main" id="{2882C7C5-B8A7-6620-5407-7BB6E583823B}"/>
                </a:ext>
              </a:extLst>
            </p:cNvPr>
            <p:cNvSpPr/>
            <p:nvPr/>
          </p:nvSpPr>
          <p:spPr>
            <a:xfrm>
              <a:off x="605197" y="3851405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DAEC301F-07F0-E7B4-C949-36269177ECE5}"/>
                </a:ext>
              </a:extLst>
            </p:cNvPr>
            <p:cNvSpPr txBox="1"/>
            <p:nvPr/>
          </p:nvSpPr>
          <p:spPr>
            <a:xfrm>
              <a:off x="605197" y="3855594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rray removal</a:t>
              </a:r>
            </a:p>
          </p:txBody>
        </p:sp>
        <p:cxnSp>
          <p:nvCxnSpPr>
            <p:cNvPr id="150" name="Straight Arrow Connector 149">
              <a:extLst>
                <a:ext uri="{FF2B5EF4-FFF2-40B4-BE49-F238E27FC236}">
                  <a16:creationId xmlns:a16="http://schemas.microsoft.com/office/drawing/2014/main" id="{4526CBCB-5B66-AC10-D61A-9A9B5667DC68}"/>
                </a:ext>
              </a:extLst>
            </p:cNvPr>
            <p:cNvCxnSpPr>
              <a:cxnSpLocks/>
            </p:cNvCxnSpPr>
            <p:nvPr/>
          </p:nvCxnSpPr>
          <p:spPr>
            <a:xfrm>
              <a:off x="1203473" y="542004"/>
              <a:ext cx="0" cy="25200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Rectangle: Rounded Corners 150">
              <a:extLst>
                <a:ext uri="{FF2B5EF4-FFF2-40B4-BE49-F238E27FC236}">
                  <a16:creationId xmlns:a16="http://schemas.microsoft.com/office/drawing/2014/main" id="{A94EC7F3-09F2-DA95-AD1F-30637F362291}"/>
                </a:ext>
              </a:extLst>
            </p:cNvPr>
            <p:cNvSpPr/>
            <p:nvPr/>
          </p:nvSpPr>
          <p:spPr>
            <a:xfrm>
              <a:off x="605197" y="286007"/>
              <a:ext cx="1196553" cy="239601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075602DB-A27F-A656-1FC3-4DB3EB83FEC4}"/>
                </a:ext>
              </a:extLst>
            </p:cNvPr>
            <p:cNvSpPr txBox="1"/>
            <p:nvPr/>
          </p:nvSpPr>
          <p:spPr>
            <a:xfrm>
              <a:off x="605197" y="263828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Sedation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B199B72A-AEBD-6DB8-00D5-ED5ADC7E664C}"/>
              </a:ext>
            </a:extLst>
          </p:cNvPr>
          <p:cNvSpPr txBox="1"/>
          <p:nvPr/>
        </p:nvSpPr>
        <p:spPr>
          <a:xfrm>
            <a:off x="264794" y="4558444"/>
            <a:ext cx="11505864" cy="2003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.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chanical Functionality Testing of </a:t>
            </a:r>
            <a:r>
              <a:rPr lang="en-US" sz="16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pical Skin Care Products in Rats</a:t>
            </a:r>
            <a:endParaRPr lang="en-IL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6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rat peeling test scheme. Peeling force was measured per rat, without (grey steps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r with </a:t>
            </a:r>
            <a:r>
              <a:rPr lang="en-US" sz="16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purple steps) topical skin care product applied, to quantify the percent change in force. </a:t>
            </a:r>
            <a:r>
              <a:rPr lang="en-US" sz="16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6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TCM-100 motorized force tester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C)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at placed on its abdomen on the moving platform of the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ce tester and the array part applied to its back. 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 adhesive strip connected to the dorsal edge of the array and to the machine’s motorized arm. 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E)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he machine arm pulling the array from the rat back.</a:t>
            </a:r>
            <a:endParaRPr lang="en-IL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80402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B2047B2-93DB-F543-640A-87429F910D0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5464E6F-5640-D993-5BC5-1A0DBB4E785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4828" y="2158420"/>
            <a:ext cx="2743835" cy="1828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917CEB1-78ED-9361-AED6-4C7CE074207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0252" y="2158420"/>
            <a:ext cx="2743835" cy="1828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5D216A5-8932-509C-C982-FAAF0B06FDF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4828" y="267821"/>
            <a:ext cx="2743835" cy="1828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E0CA6A0-6B57-E25E-83AD-4271F7BC1C5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0251" y="267821"/>
            <a:ext cx="2743835" cy="1828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8D9EAFE-90C0-3DA2-61B3-EF7A9ED0B7F4}"/>
              </a:ext>
            </a:extLst>
          </p:cNvPr>
          <p:cNvSpPr txBox="1"/>
          <p:nvPr/>
        </p:nvSpPr>
        <p:spPr>
          <a:xfrm>
            <a:off x="3279211" y="24357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en-IL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72D4B1F-E29E-7157-5F1F-B0475A3BD53B}"/>
              </a:ext>
            </a:extLst>
          </p:cNvPr>
          <p:cNvSpPr txBox="1"/>
          <p:nvPr/>
        </p:nvSpPr>
        <p:spPr>
          <a:xfrm>
            <a:off x="6084828" y="24357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  <a:endParaRPr lang="en-IL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BAFB327-C2B6-BFDE-D5C7-4801B8516F48}"/>
              </a:ext>
            </a:extLst>
          </p:cNvPr>
          <p:cNvSpPr txBox="1"/>
          <p:nvPr/>
        </p:nvSpPr>
        <p:spPr>
          <a:xfrm>
            <a:off x="3279211" y="213134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  <a:endParaRPr lang="en-IL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56FBCF9-A861-309F-78F0-86165BDF09A1}"/>
              </a:ext>
            </a:extLst>
          </p:cNvPr>
          <p:cNvSpPr txBox="1"/>
          <p:nvPr/>
        </p:nvSpPr>
        <p:spPr>
          <a:xfrm>
            <a:off x="6084828" y="213134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</a:t>
            </a:r>
            <a:endParaRPr lang="en-IL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4A9852C-C3B3-80CA-5D26-30A8512D6678}"/>
              </a:ext>
            </a:extLst>
          </p:cNvPr>
          <p:cNvSpPr txBox="1"/>
          <p:nvPr/>
        </p:nvSpPr>
        <p:spPr>
          <a:xfrm>
            <a:off x="91936" y="24357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en-IL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0CA1DBF-7E5A-C5C6-2F20-BD2B4C883E5F}"/>
              </a:ext>
            </a:extLst>
          </p:cNvPr>
          <p:cNvGrpSpPr/>
          <p:nvPr/>
        </p:nvGrpSpPr>
        <p:grpSpPr>
          <a:xfrm>
            <a:off x="430605" y="263828"/>
            <a:ext cx="2583784" cy="5369505"/>
            <a:chOff x="430605" y="263828"/>
            <a:chExt cx="2583784" cy="5369505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54C124F-DE12-6EE4-3091-C52A7A9DCB62}"/>
                </a:ext>
              </a:extLst>
            </p:cNvPr>
            <p:cNvSpPr/>
            <p:nvPr/>
          </p:nvSpPr>
          <p:spPr>
            <a:xfrm>
              <a:off x="1754389" y="3624551"/>
              <a:ext cx="1260000" cy="2003369"/>
            </a:xfrm>
            <a:prstGeom prst="rect">
              <a:avLst/>
            </a:prstGeom>
            <a:solidFill>
              <a:srgbClr val="CC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91937BEE-AEA0-13F1-F357-62C0522349D5}"/>
                </a:ext>
              </a:extLst>
            </p:cNvPr>
            <p:cNvSpPr/>
            <p:nvPr/>
          </p:nvSpPr>
          <p:spPr>
            <a:xfrm>
              <a:off x="1754388" y="1686034"/>
              <a:ext cx="1260000" cy="189837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52D2A89F-4E5E-62CE-E1D9-90F892D51689}"/>
                </a:ext>
              </a:extLst>
            </p:cNvPr>
            <p:cNvSpPr/>
            <p:nvPr/>
          </p:nvSpPr>
          <p:spPr>
            <a:xfrm>
              <a:off x="430605" y="3624551"/>
              <a:ext cx="1260000" cy="200336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378AB771-DCD4-850F-5C8C-69FAC0F4F324}"/>
                </a:ext>
              </a:extLst>
            </p:cNvPr>
            <p:cNvSpPr/>
            <p:nvPr/>
          </p:nvSpPr>
          <p:spPr>
            <a:xfrm>
              <a:off x="430605" y="1686034"/>
              <a:ext cx="1260000" cy="1898379"/>
            </a:xfrm>
            <a:prstGeom prst="rect">
              <a:avLst/>
            </a:prstGeom>
            <a:solidFill>
              <a:srgbClr val="CCCC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EE31173C-C21B-6341-0502-DE66B8E0D032}"/>
                </a:ext>
              </a:extLst>
            </p:cNvPr>
            <p:cNvCxnSpPr>
              <a:cxnSpLocks/>
            </p:cNvCxnSpPr>
            <p:nvPr/>
          </p:nvCxnSpPr>
          <p:spPr>
            <a:xfrm>
              <a:off x="1322566" y="1496768"/>
              <a:ext cx="0" cy="36576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B4E785FD-20E1-0A16-7A7E-D8BD834B05B1}"/>
                </a:ext>
              </a:extLst>
            </p:cNvPr>
            <p:cNvCxnSpPr>
              <a:cxnSpLocks/>
            </p:cNvCxnSpPr>
            <p:nvPr/>
          </p:nvCxnSpPr>
          <p:spPr>
            <a:xfrm>
              <a:off x="1678696" y="1050089"/>
              <a:ext cx="0" cy="25200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C9A084C8-03D6-E3DF-641C-65AFB6E37A3B}"/>
                </a:ext>
              </a:extLst>
            </p:cNvPr>
            <p:cNvCxnSpPr>
              <a:cxnSpLocks/>
            </p:cNvCxnSpPr>
            <p:nvPr/>
          </p:nvCxnSpPr>
          <p:spPr>
            <a:xfrm>
              <a:off x="1322566" y="4193333"/>
              <a:ext cx="0" cy="144000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FB6B544B-9F10-84D3-DA75-B6E8238AB8D7}"/>
                </a:ext>
              </a:extLst>
            </p:cNvPr>
            <p:cNvCxnSpPr>
              <a:cxnSpLocks/>
            </p:cNvCxnSpPr>
            <p:nvPr/>
          </p:nvCxnSpPr>
          <p:spPr>
            <a:xfrm>
              <a:off x="2083319" y="4444347"/>
              <a:ext cx="0" cy="118800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945C012D-C1B6-F36F-F7CD-CAC5887CD193}"/>
                </a:ext>
              </a:extLst>
            </p:cNvPr>
            <p:cNvCxnSpPr>
              <a:cxnSpLocks/>
            </p:cNvCxnSpPr>
            <p:nvPr/>
          </p:nvCxnSpPr>
          <p:spPr>
            <a:xfrm>
              <a:off x="1322566" y="2494495"/>
              <a:ext cx="0" cy="140400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0F7232AD-4169-5E24-DA99-23692D38321A}"/>
                </a:ext>
              </a:extLst>
            </p:cNvPr>
            <p:cNvCxnSpPr>
              <a:cxnSpLocks/>
            </p:cNvCxnSpPr>
            <p:nvPr/>
          </p:nvCxnSpPr>
          <p:spPr>
            <a:xfrm>
              <a:off x="2083319" y="2254808"/>
              <a:ext cx="0" cy="154800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Rectangle: Rounded Corners 23">
              <a:extLst>
                <a:ext uri="{FF2B5EF4-FFF2-40B4-BE49-F238E27FC236}">
                  <a16:creationId xmlns:a16="http://schemas.microsoft.com/office/drawing/2014/main" id="{7D74564F-AD91-5204-4059-781C433CBBA9}"/>
                </a:ext>
              </a:extLst>
            </p:cNvPr>
            <p:cNvSpPr/>
            <p:nvPr/>
          </p:nvSpPr>
          <p:spPr>
            <a:xfrm>
              <a:off x="1076076" y="2552603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5" name="Rectangle: Rounded Corners 24">
              <a:extLst>
                <a:ext uri="{FF2B5EF4-FFF2-40B4-BE49-F238E27FC236}">
                  <a16:creationId xmlns:a16="http://schemas.microsoft.com/office/drawing/2014/main" id="{E33111C8-4B9F-482A-4FAF-C21D14EEAF39}"/>
                </a:ext>
              </a:extLst>
            </p:cNvPr>
            <p:cNvSpPr/>
            <p:nvPr/>
          </p:nvSpPr>
          <p:spPr>
            <a:xfrm>
              <a:off x="1076076" y="794092"/>
              <a:ext cx="1196553" cy="239601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6" name="Rectangle: Rounded Corners 25">
              <a:extLst>
                <a:ext uri="{FF2B5EF4-FFF2-40B4-BE49-F238E27FC236}">
                  <a16:creationId xmlns:a16="http://schemas.microsoft.com/office/drawing/2014/main" id="{3F9AB887-6998-830C-C741-6FF1DC9CD3E5}"/>
                </a:ext>
              </a:extLst>
            </p:cNvPr>
            <p:cNvSpPr/>
            <p:nvPr/>
          </p:nvSpPr>
          <p:spPr>
            <a:xfrm>
              <a:off x="1076076" y="1306186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8" name="Rectangle: Rounded Corners 27">
              <a:extLst>
                <a:ext uri="{FF2B5EF4-FFF2-40B4-BE49-F238E27FC236}">
                  <a16:creationId xmlns:a16="http://schemas.microsoft.com/office/drawing/2014/main" id="{89C4E9FF-500B-6BB5-FD11-67BF83EEC6EC}"/>
                </a:ext>
              </a:extLst>
            </p:cNvPr>
            <p:cNvSpPr/>
            <p:nvPr/>
          </p:nvSpPr>
          <p:spPr>
            <a:xfrm>
              <a:off x="477002" y="1862528"/>
              <a:ext cx="1152000" cy="619073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29" name="Rectangle: Rounded Corners 28">
              <a:extLst>
                <a:ext uri="{FF2B5EF4-FFF2-40B4-BE49-F238E27FC236}">
                  <a16:creationId xmlns:a16="http://schemas.microsoft.com/office/drawing/2014/main" id="{EDE11379-22D8-06C8-C941-855974A82CFF}"/>
                </a:ext>
              </a:extLst>
            </p:cNvPr>
            <p:cNvSpPr/>
            <p:nvPr/>
          </p:nvSpPr>
          <p:spPr>
            <a:xfrm>
              <a:off x="1076076" y="2904792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30" name="Rectangle: Rounded Corners 29">
              <a:extLst>
                <a:ext uri="{FF2B5EF4-FFF2-40B4-BE49-F238E27FC236}">
                  <a16:creationId xmlns:a16="http://schemas.microsoft.com/office/drawing/2014/main" id="{CB1CC85D-D28C-4163-ED33-31BA1921B813}"/>
                </a:ext>
              </a:extLst>
            </p:cNvPr>
            <p:cNvSpPr/>
            <p:nvPr/>
          </p:nvSpPr>
          <p:spPr>
            <a:xfrm>
              <a:off x="477002" y="3910987"/>
              <a:ext cx="1152000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32" name="Rectangle: Rounded Corners 31">
              <a:extLst>
                <a:ext uri="{FF2B5EF4-FFF2-40B4-BE49-F238E27FC236}">
                  <a16:creationId xmlns:a16="http://schemas.microsoft.com/office/drawing/2014/main" id="{9DB5CBE2-D4E0-4017-766A-23C84A7F457C}"/>
                </a:ext>
              </a:extLst>
            </p:cNvPr>
            <p:cNvSpPr/>
            <p:nvPr/>
          </p:nvSpPr>
          <p:spPr>
            <a:xfrm>
              <a:off x="1798910" y="3811740"/>
              <a:ext cx="1152000" cy="619073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34" name="Rectangle: Rounded Corners 33">
              <a:extLst>
                <a:ext uri="{FF2B5EF4-FFF2-40B4-BE49-F238E27FC236}">
                  <a16:creationId xmlns:a16="http://schemas.microsoft.com/office/drawing/2014/main" id="{4BAEADB2-1B62-FDD0-B327-925B0CCECAD2}"/>
                </a:ext>
              </a:extLst>
            </p:cNvPr>
            <p:cNvSpPr/>
            <p:nvPr/>
          </p:nvSpPr>
          <p:spPr>
            <a:xfrm>
              <a:off x="1798910" y="1961775"/>
              <a:ext cx="1152000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98CC62F-3F12-CB1F-9721-878F4DEBBE55}"/>
                </a:ext>
              </a:extLst>
            </p:cNvPr>
            <p:cNvSpPr txBox="1"/>
            <p:nvPr/>
          </p:nvSpPr>
          <p:spPr>
            <a:xfrm>
              <a:off x="1076076" y="2556792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rray assembly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7F4342B-44B4-4F93-B8FF-C94751EC166A}"/>
                </a:ext>
              </a:extLst>
            </p:cNvPr>
            <p:cNvSpPr txBox="1"/>
            <p:nvPr/>
          </p:nvSpPr>
          <p:spPr>
            <a:xfrm>
              <a:off x="1076076" y="771913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orso depilation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6385494-F2C8-F079-CAAB-2A4963F289BB}"/>
                </a:ext>
              </a:extLst>
            </p:cNvPr>
            <p:cNvSpPr txBox="1"/>
            <p:nvPr/>
          </p:nvSpPr>
          <p:spPr>
            <a:xfrm>
              <a:off x="1076076" y="1310375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Randomization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6333934-1607-730F-CB87-7CBEFF426828}"/>
                </a:ext>
              </a:extLst>
            </p:cNvPr>
            <p:cNvSpPr txBox="1"/>
            <p:nvPr/>
          </p:nvSpPr>
          <p:spPr>
            <a:xfrm>
              <a:off x="477002" y="1839715"/>
              <a:ext cx="11520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opical skin care product application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0E72057-A19A-4741-6D50-A31282AF9B84}"/>
                </a:ext>
              </a:extLst>
            </p:cNvPr>
            <p:cNvSpPr txBox="1"/>
            <p:nvPr/>
          </p:nvSpPr>
          <p:spPr>
            <a:xfrm>
              <a:off x="1076075" y="2908981"/>
              <a:ext cx="122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TFields delivery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758C368F-2AD6-4109-D6B7-EBAC9DEF89CA}"/>
                </a:ext>
              </a:extLst>
            </p:cNvPr>
            <p:cNvSpPr txBox="1"/>
            <p:nvPr/>
          </p:nvSpPr>
          <p:spPr>
            <a:xfrm>
              <a:off x="477002" y="3915176"/>
              <a:ext cx="11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orso cleansing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549CED7-0A9F-2664-1BCF-B5F23D77F7C1}"/>
                </a:ext>
              </a:extLst>
            </p:cNvPr>
            <p:cNvSpPr txBox="1"/>
            <p:nvPr/>
          </p:nvSpPr>
          <p:spPr>
            <a:xfrm>
              <a:off x="1798910" y="3796133"/>
              <a:ext cx="11520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opical skin care product application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A9D2EB3-9F66-6B9E-1333-87970E793F71}"/>
                </a:ext>
              </a:extLst>
            </p:cNvPr>
            <p:cNvSpPr txBox="1"/>
            <p:nvPr/>
          </p:nvSpPr>
          <p:spPr>
            <a:xfrm>
              <a:off x="1798910" y="1965964"/>
              <a:ext cx="115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orso cleansing</a:t>
              </a:r>
            </a:p>
          </p:txBody>
        </p: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3F539635-F4C5-3FFD-53DF-1EEA15D62518}"/>
                </a:ext>
              </a:extLst>
            </p:cNvPr>
            <p:cNvCxnSpPr>
              <a:cxnSpLocks/>
            </p:cNvCxnSpPr>
            <p:nvPr/>
          </p:nvCxnSpPr>
          <p:spPr>
            <a:xfrm>
              <a:off x="2083319" y="1572968"/>
              <a:ext cx="0" cy="36576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Rectangle: Rounded Corners 74">
              <a:extLst>
                <a:ext uri="{FF2B5EF4-FFF2-40B4-BE49-F238E27FC236}">
                  <a16:creationId xmlns:a16="http://schemas.microsoft.com/office/drawing/2014/main" id="{92E924B8-7D3B-CC1C-77DE-DD937F86F024}"/>
                </a:ext>
              </a:extLst>
            </p:cNvPr>
            <p:cNvSpPr/>
            <p:nvPr/>
          </p:nvSpPr>
          <p:spPr>
            <a:xfrm>
              <a:off x="1076076" y="3253077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27504EF6-FBE4-1CF8-0FA9-F2963B6EC6F0}"/>
                </a:ext>
              </a:extLst>
            </p:cNvPr>
            <p:cNvSpPr txBox="1"/>
            <p:nvPr/>
          </p:nvSpPr>
          <p:spPr>
            <a:xfrm>
              <a:off x="1076076" y="3257266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rray removal</a:t>
              </a:r>
            </a:p>
          </p:txBody>
        </p:sp>
        <p:sp>
          <p:nvSpPr>
            <p:cNvPr id="77" name="Rectangle: Rounded Corners 76">
              <a:extLst>
                <a:ext uri="{FF2B5EF4-FFF2-40B4-BE49-F238E27FC236}">
                  <a16:creationId xmlns:a16="http://schemas.microsoft.com/office/drawing/2014/main" id="{2647936C-835B-4535-59C3-9C85FF207393}"/>
                </a:ext>
              </a:extLst>
            </p:cNvPr>
            <p:cNvSpPr/>
            <p:nvPr/>
          </p:nvSpPr>
          <p:spPr>
            <a:xfrm>
              <a:off x="1076076" y="4574647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78" name="Rectangle: Rounded Corners 77">
              <a:extLst>
                <a:ext uri="{FF2B5EF4-FFF2-40B4-BE49-F238E27FC236}">
                  <a16:creationId xmlns:a16="http://schemas.microsoft.com/office/drawing/2014/main" id="{905422F8-E23B-821E-ED11-B5B650C1E056}"/>
                </a:ext>
              </a:extLst>
            </p:cNvPr>
            <p:cNvSpPr/>
            <p:nvPr/>
          </p:nvSpPr>
          <p:spPr>
            <a:xfrm>
              <a:off x="1076076" y="4926836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DE402C84-4071-015D-38A9-8300C7CAF1F8}"/>
                </a:ext>
              </a:extLst>
            </p:cNvPr>
            <p:cNvSpPr txBox="1"/>
            <p:nvPr/>
          </p:nvSpPr>
          <p:spPr>
            <a:xfrm>
              <a:off x="1076076" y="4578836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rray assembly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10575D91-9D4C-4BEC-43FB-289B90B0973F}"/>
                </a:ext>
              </a:extLst>
            </p:cNvPr>
            <p:cNvSpPr txBox="1"/>
            <p:nvPr/>
          </p:nvSpPr>
          <p:spPr>
            <a:xfrm>
              <a:off x="1076075" y="4931025"/>
              <a:ext cx="122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TFields delivery</a:t>
              </a:r>
            </a:p>
          </p:txBody>
        </p:sp>
        <p:sp>
          <p:nvSpPr>
            <p:cNvPr id="81" name="Rectangle: Rounded Corners 80">
              <a:extLst>
                <a:ext uri="{FF2B5EF4-FFF2-40B4-BE49-F238E27FC236}">
                  <a16:creationId xmlns:a16="http://schemas.microsoft.com/office/drawing/2014/main" id="{0A6F5D44-45AF-D54F-4BA7-9AF72AE2ECBD}"/>
                </a:ext>
              </a:extLst>
            </p:cNvPr>
            <p:cNvSpPr/>
            <p:nvPr/>
          </p:nvSpPr>
          <p:spPr>
            <a:xfrm>
              <a:off x="1076076" y="5275121"/>
              <a:ext cx="1196553" cy="278206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961B0ADA-68BE-2DE4-F6AB-E144655D827A}"/>
                </a:ext>
              </a:extLst>
            </p:cNvPr>
            <p:cNvSpPr txBox="1"/>
            <p:nvPr/>
          </p:nvSpPr>
          <p:spPr>
            <a:xfrm>
              <a:off x="1076076" y="5279310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rray removal</a:t>
              </a:r>
            </a:p>
          </p:txBody>
        </p:sp>
        <p:cxnSp>
          <p:nvCxnSpPr>
            <p:cNvPr id="149" name="Straight Arrow Connector 148">
              <a:extLst>
                <a:ext uri="{FF2B5EF4-FFF2-40B4-BE49-F238E27FC236}">
                  <a16:creationId xmlns:a16="http://schemas.microsoft.com/office/drawing/2014/main" id="{F12750F3-890A-8C3D-7012-190AC472CFFA}"/>
                </a:ext>
              </a:extLst>
            </p:cNvPr>
            <p:cNvCxnSpPr>
              <a:cxnSpLocks/>
            </p:cNvCxnSpPr>
            <p:nvPr/>
          </p:nvCxnSpPr>
          <p:spPr>
            <a:xfrm>
              <a:off x="1678696" y="542004"/>
              <a:ext cx="0" cy="25200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Rectangle: Rounded Corners 149">
              <a:extLst>
                <a:ext uri="{FF2B5EF4-FFF2-40B4-BE49-F238E27FC236}">
                  <a16:creationId xmlns:a16="http://schemas.microsoft.com/office/drawing/2014/main" id="{D46F41BF-5267-2584-C784-7714EF568FA4}"/>
                </a:ext>
              </a:extLst>
            </p:cNvPr>
            <p:cNvSpPr/>
            <p:nvPr/>
          </p:nvSpPr>
          <p:spPr>
            <a:xfrm>
              <a:off x="1076076" y="286007"/>
              <a:ext cx="1196553" cy="239601"/>
            </a:xfrm>
            <a:prstGeom prst="roundRect">
              <a:avLst/>
            </a:prstGeom>
            <a:solidFill>
              <a:schemeClr val="bg1"/>
            </a:solidFill>
            <a:ln w="285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A4150476-E683-53BC-0AE6-2699230E03B0}"/>
                </a:ext>
              </a:extLst>
            </p:cNvPr>
            <p:cNvSpPr txBox="1"/>
            <p:nvPr/>
          </p:nvSpPr>
          <p:spPr>
            <a:xfrm>
              <a:off x="1076076" y="263828"/>
              <a:ext cx="1196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Sedation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B3640B33-82D1-0376-8253-720F53AC8F5F}"/>
              </a:ext>
            </a:extLst>
          </p:cNvPr>
          <p:cNvSpPr txBox="1"/>
          <p:nvPr/>
        </p:nvSpPr>
        <p:spPr>
          <a:xfrm>
            <a:off x="3266764" y="4306644"/>
            <a:ext cx="7849160" cy="2003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.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lectrical Functionality Testing of </a:t>
            </a:r>
            <a:r>
              <a:rPr lang="en-US" sz="16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pical Skin Care Products in Rats</a:t>
            </a:r>
            <a:endParaRPr lang="en-IL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6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 rat current test scheme. Current was measured per rat during application of TTFields (200 kHz), without (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ey steps) or with (purple steps) topical skin care product applied, to quantify the percent change in current. 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-E)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at torso arrays were applied to the animal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cured using a hypo-allergenic, medical-grade adhesive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endParaRPr lang="en-IL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6707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261</Words>
  <Application>Microsoft Office PowerPoint</Application>
  <PresentationFormat>Widescreen</PresentationFormat>
  <Paragraphs>3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i Haber</dc:creator>
  <cp:lastModifiedBy>Adi Haber</cp:lastModifiedBy>
  <cp:revision>25</cp:revision>
  <dcterms:created xsi:type="dcterms:W3CDTF">2023-10-18T12:48:16Z</dcterms:created>
  <dcterms:modified xsi:type="dcterms:W3CDTF">2025-10-28T07:59:51Z</dcterms:modified>
</cp:coreProperties>
</file>